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9212FF-204C-49ED-A593-E53D2035194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7AB853-AED2-405E-8AF5-73B056AC05A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1341E0-7D40-40EE-9881-F4BE71D3547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6E3F53-6E6F-4E88-BA9B-D7FA9C9D7EF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85A1EE-E5A6-4205-A804-C0A99686F13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CE6142-58B8-4264-9F0D-A80CE6D10EA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BDDB64-A60A-4C9F-9DF5-3378F3D7440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60248F-CBA6-419A-A542-2AEEF2A6E67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6C9DA9-F864-454F-8668-CD5EEA10684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EF0095-AED3-4C37-91E2-902E037500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702202-817A-4222-9962-88E3C54C715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835147-AC7C-4147-BB4F-38B5AA3E60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50703717-91FA-4639-AA0F-2E289CADE72D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テキスト ボックス 86"/>
          <p:cNvSpPr/>
          <p:nvPr/>
        </p:nvSpPr>
        <p:spPr>
          <a:xfrm>
            <a:off x="14400" y="-1440"/>
            <a:ext cx="29347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Supplement Figure. S2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図 85" descr=""/>
          <p:cNvPicPr/>
          <p:nvPr/>
        </p:nvPicPr>
        <p:blipFill>
          <a:blip r:embed="rId1"/>
          <a:stretch/>
        </p:blipFill>
        <p:spPr>
          <a:xfrm>
            <a:off x="3349800" y="3645000"/>
            <a:ext cx="2131920" cy="1485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3" name="テキスト ボックス 86"/>
          <p:cNvSpPr/>
          <p:nvPr/>
        </p:nvSpPr>
        <p:spPr>
          <a:xfrm rot="5400000">
            <a:off x="5203080" y="2660760"/>
            <a:ext cx="10890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B: </a:t>
            </a:r>
            <a:r>
              <a:rPr b="1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α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synuclei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(synuclein-1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テキスト ボックス 87"/>
          <p:cNvSpPr/>
          <p:nvPr/>
        </p:nvSpPr>
        <p:spPr>
          <a:xfrm rot="5400000">
            <a:off x="5116320" y="4163760"/>
            <a:ext cx="12870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B: </a:t>
            </a:r>
            <a:r>
              <a:rPr b="1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synuclei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(BD Transduction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テキスト ボックス 88"/>
          <p:cNvSpPr/>
          <p:nvPr/>
        </p:nvSpPr>
        <p:spPr>
          <a:xfrm rot="5400000">
            <a:off x="5214240" y="5771880"/>
            <a:ext cx="10814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B: </a:t>
            </a:r>
            <a:r>
              <a:rPr b="1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γ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synuclei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(GeneTex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 Box 95"/>
          <p:cNvSpPr/>
          <p:nvPr/>
        </p:nvSpPr>
        <p:spPr>
          <a:xfrm>
            <a:off x="3119760" y="302436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23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 Box 96"/>
          <p:cNvSpPr/>
          <p:nvPr/>
        </p:nvSpPr>
        <p:spPr>
          <a:xfrm>
            <a:off x="3119400" y="2798640"/>
            <a:ext cx="3031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3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 Box 97"/>
          <p:cNvSpPr/>
          <p:nvPr/>
        </p:nvSpPr>
        <p:spPr>
          <a:xfrm>
            <a:off x="3119760" y="251136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46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 Box 98"/>
          <p:cNvSpPr/>
          <p:nvPr/>
        </p:nvSpPr>
        <p:spPr>
          <a:xfrm>
            <a:off x="3119760" y="228132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58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 Box 99"/>
          <p:cNvSpPr/>
          <p:nvPr/>
        </p:nvSpPr>
        <p:spPr>
          <a:xfrm>
            <a:off x="3121200" y="215100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8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Line 101"/>
          <p:cNvSpPr/>
          <p:nvPr/>
        </p:nvSpPr>
        <p:spPr>
          <a:xfrm>
            <a:off x="3324240" y="2886120"/>
            <a:ext cx="30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Line 102"/>
          <p:cNvSpPr/>
          <p:nvPr/>
        </p:nvSpPr>
        <p:spPr>
          <a:xfrm>
            <a:off x="3324240" y="2610000"/>
            <a:ext cx="30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Line 103"/>
          <p:cNvSpPr/>
          <p:nvPr/>
        </p:nvSpPr>
        <p:spPr>
          <a:xfrm>
            <a:off x="3319560" y="3124080"/>
            <a:ext cx="30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Line 104"/>
          <p:cNvSpPr/>
          <p:nvPr/>
        </p:nvSpPr>
        <p:spPr>
          <a:xfrm>
            <a:off x="3319560" y="2246400"/>
            <a:ext cx="30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Line 105"/>
          <p:cNvSpPr/>
          <p:nvPr/>
        </p:nvSpPr>
        <p:spPr>
          <a:xfrm>
            <a:off x="3324240" y="2392200"/>
            <a:ext cx="30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 Box 106"/>
          <p:cNvSpPr/>
          <p:nvPr/>
        </p:nvSpPr>
        <p:spPr>
          <a:xfrm>
            <a:off x="3082320" y="2036880"/>
            <a:ext cx="30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175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Line 107"/>
          <p:cNvSpPr/>
          <p:nvPr/>
        </p:nvSpPr>
        <p:spPr>
          <a:xfrm>
            <a:off x="3319560" y="2143080"/>
            <a:ext cx="30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 Box 95"/>
          <p:cNvSpPr/>
          <p:nvPr/>
        </p:nvSpPr>
        <p:spPr>
          <a:xfrm>
            <a:off x="3117960" y="325296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17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Line 103"/>
          <p:cNvSpPr/>
          <p:nvPr/>
        </p:nvSpPr>
        <p:spPr>
          <a:xfrm flipH="1">
            <a:off x="3317760" y="3352680"/>
            <a:ext cx="44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0" name="図 103" descr=""/>
          <p:cNvPicPr/>
          <p:nvPr/>
        </p:nvPicPr>
        <p:blipFill>
          <a:blip r:embed="rId2"/>
          <a:stretch/>
        </p:blipFill>
        <p:spPr>
          <a:xfrm>
            <a:off x="3349800" y="2093760"/>
            <a:ext cx="2131920" cy="14875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61" name="Text Box 95"/>
          <p:cNvSpPr/>
          <p:nvPr/>
        </p:nvSpPr>
        <p:spPr>
          <a:xfrm>
            <a:off x="3101400" y="456084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23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 Box 96"/>
          <p:cNvSpPr/>
          <p:nvPr/>
        </p:nvSpPr>
        <p:spPr>
          <a:xfrm>
            <a:off x="3100320" y="4334040"/>
            <a:ext cx="3031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3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 Box 97"/>
          <p:cNvSpPr/>
          <p:nvPr/>
        </p:nvSpPr>
        <p:spPr>
          <a:xfrm>
            <a:off x="3101400" y="404820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46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 Box 98"/>
          <p:cNvSpPr/>
          <p:nvPr/>
        </p:nvSpPr>
        <p:spPr>
          <a:xfrm>
            <a:off x="3101400" y="381636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58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 Box 99"/>
          <p:cNvSpPr/>
          <p:nvPr/>
        </p:nvSpPr>
        <p:spPr>
          <a:xfrm>
            <a:off x="3102840" y="368784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8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Line 101"/>
          <p:cNvSpPr/>
          <p:nvPr/>
        </p:nvSpPr>
        <p:spPr>
          <a:xfrm>
            <a:off x="3305160" y="4422600"/>
            <a:ext cx="30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Line 102"/>
          <p:cNvSpPr/>
          <p:nvPr/>
        </p:nvSpPr>
        <p:spPr>
          <a:xfrm>
            <a:off x="3305160" y="4145040"/>
            <a:ext cx="30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Line 103"/>
          <p:cNvSpPr/>
          <p:nvPr/>
        </p:nvSpPr>
        <p:spPr>
          <a:xfrm>
            <a:off x="3301920" y="4659480"/>
            <a:ext cx="30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Line 104"/>
          <p:cNvSpPr/>
          <p:nvPr/>
        </p:nvSpPr>
        <p:spPr>
          <a:xfrm>
            <a:off x="3301920" y="3781440"/>
            <a:ext cx="30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Line 105"/>
          <p:cNvSpPr/>
          <p:nvPr/>
        </p:nvSpPr>
        <p:spPr>
          <a:xfrm>
            <a:off x="3305160" y="3927600"/>
            <a:ext cx="30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 Box 106"/>
          <p:cNvSpPr/>
          <p:nvPr/>
        </p:nvSpPr>
        <p:spPr>
          <a:xfrm>
            <a:off x="3063960" y="3573360"/>
            <a:ext cx="30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175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Line 107"/>
          <p:cNvSpPr/>
          <p:nvPr/>
        </p:nvSpPr>
        <p:spPr>
          <a:xfrm>
            <a:off x="3301920" y="3678120"/>
            <a:ext cx="30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 Box 95"/>
          <p:cNvSpPr/>
          <p:nvPr/>
        </p:nvSpPr>
        <p:spPr>
          <a:xfrm>
            <a:off x="3098880" y="478800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17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Line 103"/>
          <p:cNvSpPr/>
          <p:nvPr/>
        </p:nvSpPr>
        <p:spPr>
          <a:xfrm flipH="1">
            <a:off x="3298680" y="4888080"/>
            <a:ext cx="46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 Box 95"/>
          <p:cNvSpPr/>
          <p:nvPr/>
        </p:nvSpPr>
        <p:spPr>
          <a:xfrm>
            <a:off x="3101400" y="615960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23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 Box 96"/>
          <p:cNvSpPr/>
          <p:nvPr/>
        </p:nvSpPr>
        <p:spPr>
          <a:xfrm>
            <a:off x="3100320" y="5932440"/>
            <a:ext cx="3031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3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 Box 97"/>
          <p:cNvSpPr/>
          <p:nvPr/>
        </p:nvSpPr>
        <p:spPr>
          <a:xfrm>
            <a:off x="3101400" y="564660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46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 Box 98"/>
          <p:cNvSpPr/>
          <p:nvPr/>
        </p:nvSpPr>
        <p:spPr>
          <a:xfrm>
            <a:off x="3101400" y="541512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58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 Box 99"/>
          <p:cNvSpPr/>
          <p:nvPr/>
        </p:nvSpPr>
        <p:spPr>
          <a:xfrm>
            <a:off x="3102840" y="528624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8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Line 101"/>
          <p:cNvSpPr/>
          <p:nvPr/>
        </p:nvSpPr>
        <p:spPr>
          <a:xfrm>
            <a:off x="3305160" y="6021360"/>
            <a:ext cx="30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Line 102"/>
          <p:cNvSpPr/>
          <p:nvPr/>
        </p:nvSpPr>
        <p:spPr>
          <a:xfrm>
            <a:off x="3305160" y="5743440"/>
            <a:ext cx="30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Line 103"/>
          <p:cNvSpPr/>
          <p:nvPr/>
        </p:nvSpPr>
        <p:spPr>
          <a:xfrm>
            <a:off x="3301920" y="6257880"/>
            <a:ext cx="30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Line 104"/>
          <p:cNvSpPr/>
          <p:nvPr/>
        </p:nvSpPr>
        <p:spPr>
          <a:xfrm>
            <a:off x="3301920" y="5381640"/>
            <a:ext cx="30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Line 105"/>
          <p:cNvSpPr/>
          <p:nvPr/>
        </p:nvSpPr>
        <p:spPr>
          <a:xfrm>
            <a:off x="3305160" y="5526000"/>
            <a:ext cx="30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Text Box 106"/>
          <p:cNvSpPr/>
          <p:nvPr/>
        </p:nvSpPr>
        <p:spPr>
          <a:xfrm>
            <a:off x="3063960" y="5172120"/>
            <a:ext cx="30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175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Line 107"/>
          <p:cNvSpPr/>
          <p:nvPr/>
        </p:nvSpPr>
        <p:spPr>
          <a:xfrm>
            <a:off x="3301920" y="5276880"/>
            <a:ext cx="30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Text Box 95"/>
          <p:cNvSpPr/>
          <p:nvPr/>
        </p:nvSpPr>
        <p:spPr>
          <a:xfrm>
            <a:off x="3098880" y="638640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17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Line 103"/>
          <p:cNvSpPr/>
          <p:nvPr/>
        </p:nvSpPr>
        <p:spPr>
          <a:xfrm flipH="1">
            <a:off x="3298680" y="6486480"/>
            <a:ext cx="46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テキスト ボックス 138"/>
          <p:cNvSpPr/>
          <p:nvPr/>
        </p:nvSpPr>
        <p:spPr>
          <a:xfrm>
            <a:off x="3084840" y="7186680"/>
            <a:ext cx="3164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kDa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0" name="図 139" descr=""/>
          <p:cNvPicPr/>
          <p:nvPr/>
        </p:nvPicPr>
        <p:blipFill>
          <a:blip r:embed="rId3"/>
          <a:stretch/>
        </p:blipFill>
        <p:spPr>
          <a:xfrm>
            <a:off x="3349800" y="5194440"/>
            <a:ext cx="2131920" cy="15890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91" name="テキスト ボックス 140"/>
          <p:cNvSpPr/>
          <p:nvPr/>
        </p:nvSpPr>
        <p:spPr>
          <a:xfrm>
            <a:off x="5470560" y="7083360"/>
            <a:ext cx="1171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B: Na/K ATPas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テキスト ボックス 141"/>
          <p:cNvSpPr/>
          <p:nvPr/>
        </p:nvSpPr>
        <p:spPr>
          <a:xfrm>
            <a:off x="5469120" y="6807240"/>
            <a:ext cx="764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B: Hsp9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3" name="図 142" descr=""/>
          <p:cNvPicPr/>
          <p:nvPr/>
        </p:nvPicPr>
        <p:blipFill>
          <a:blip r:embed="rId4"/>
          <a:stretch/>
        </p:blipFill>
        <p:spPr>
          <a:xfrm>
            <a:off x="3344760" y="6824520"/>
            <a:ext cx="2136960" cy="235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94" name="Text Box 95"/>
          <p:cNvSpPr/>
          <p:nvPr/>
        </p:nvSpPr>
        <p:spPr>
          <a:xfrm>
            <a:off x="3091680" y="689940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8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Line 103"/>
          <p:cNvSpPr/>
          <p:nvPr/>
        </p:nvSpPr>
        <p:spPr>
          <a:xfrm flipH="1">
            <a:off x="3290760" y="6999120"/>
            <a:ext cx="46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Text Box 95"/>
          <p:cNvSpPr/>
          <p:nvPr/>
        </p:nvSpPr>
        <p:spPr>
          <a:xfrm>
            <a:off x="3086280" y="704520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8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Line 103"/>
          <p:cNvSpPr/>
          <p:nvPr/>
        </p:nvSpPr>
        <p:spPr>
          <a:xfrm flipH="1">
            <a:off x="3284640" y="7145280"/>
            <a:ext cx="46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テキスト ボックス 147"/>
          <p:cNvSpPr/>
          <p:nvPr/>
        </p:nvSpPr>
        <p:spPr>
          <a:xfrm rot="16200000">
            <a:off x="4417920" y="1106280"/>
            <a:ext cx="997920" cy="100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Untreated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wt-type </a:t>
            </a:r>
            <a:r>
              <a:rPr b="1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α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Y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53T</a:t>
            </a:r>
            <a:r>
              <a:rPr b="1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 α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Y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30P</a:t>
            </a:r>
            <a:r>
              <a:rPr b="1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 α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Y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Y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γ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Y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テキスト ボックス 148"/>
          <p:cNvSpPr/>
          <p:nvPr/>
        </p:nvSpPr>
        <p:spPr>
          <a:xfrm>
            <a:off x="3206880" y="757080"/>
            <a:ext cx="1295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Hydrophobic membrane fractio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テキスト ボックス 149"/>
          <p:cNvSpPr/>
          <p:nvPr/>
        </p:nvSpPr>
        <p:spPr>
          <a:xfrm>
            <a:off x="4357800" y="814320"/>
            <a:ext cx="1296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Hydrophilic fractio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直線コネクタ 150"/>
          <p:cNvSpPr/>
          <p:nvPr/>
        </p:nvSpPr>
        <p:spPr>
          <a:xfrm>
            <a:off x="3278160" y="1128600"/>
            <a:ext cx="109692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直線コネクタ 151"/>
          <p:cNvSpPr/>
          <p:nvPr/>
        </p:nvSpPr>
        <p:spPr>
          <a:xfrm>
            <a:off x="4430880" y="1128600"/>
            <a:ext cx="109692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テキスト ボックス 152"/>
          <p:cNvSpPr/>
          <p:nvPr/>
        </p:nvSpPr>
        <p:spPr>
          <a:xfrm rot="16200000">
            <a:off x="3317760" y="1106280"/>
            <a:ext cx="997920" cy="100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Untreated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wt-type </a:t>
            </a:r>
            <a:r>
              <a:rPr b="1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α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Y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53T</a:t>
            </a:r>
            <a:r>
              <a:rPr b="1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 α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Y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30P</a:t>
            </a:r>
            <a:r>
              <a:rPr b="1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 α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Y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Y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γ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Y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4" name="図 153" descr=""/>
          <p:cNvPicPr/>
          <p:nvPr/>
        </p:nvPicPr>
        <p:blipFill>
          <a:blip r:embed="rId5"/>
          <a:stretch/>
        </p:blipFill>
        <p:spPr>
          <a:xfrm rot="5400000">
            <a:off x="4292640" y="6153120"/>
            <a:ext cx="241200" cy="21369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05" name="テキスト ボックス 154"/>
          <p:cNvSpPr/>
          <p:nvPr/>
        </p:nvSpPr>
        <p:spPr>
          <a:xfrm rot="19240200">
            <a:off x="1196280" y="1567080"/>
            <a:ext cx="740160" cy="29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Myc-</a:t>
            </a:r>
            <a:r>
              <a:rPr b="1" lang="el-GR" sz="900" spc="-1" strike="noStrike">
                <a:solidFill>
                  <a:srgbClr val="000000"/>
                </a:solidFill>
                <a:latin typeface="Arial"/>
                <a:ea typeface="Arial"/>
              </a:rPr>
              <a:t>γ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SY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6" name="図 155" descr=""/>
          <p:cNvPicPr/>
          <p:nvPr/>
        </p:nvPicPr>
        <p:blipFill>
          <a:blip r:embed="rId6"/>
          <a:stretch/>
        </p:blipFill>
        <p:spPr>
          <a:xfrm>
            <a:off x="789120" y="2000160"/>
            <a:ext cx="739800" cy="2318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07" name="図 156" descr=""/>
          <p:cNvPicPr/>
          <p:nvPr/>
        </p:nvPicPr>
        <p:blipFill>
          <a:blip r:embed="rId7"/>
          <a:stretch/>
        </p:blipFill>
        <p:spPr>
          <a:xfrm>
            <a:off x="789120" y="2930400"/>
            <a:ext cx="742680" cy="2397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08" name="図 157" descr=""/>
          <p:cNvPicPr/>
          <p:nvPr/>
        </p:nvPicPr>
        <p:blipFill>
          <a:blip r:embed="rId8"/>
          <a:stretch/>
        </p:blipFill>
        <p:spPr>
          <a:xfrm>
            <a:off x="789120" y="2314440"/>
            <a:ext cx="739800" cy="2239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09" name="図 158" descr=""/>
          <p:cNvPicPr/>
          <p:nvPr/>
        </p:nvPicPr>
        <p:blipFill>
          <a:blip r:embed="rId9"/>
          <a:stretch/>
        </p:blipFill>
        <p:spPr>
          <a:xfrm>
            <a:off x="789120" y="2620800"/>
            <a:ext cx="742680" cy="2271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10" name="テキスト ボックス 159"/>
          <p:cNvSpPr/>
          <p:nvPr/>
        </p:nvSpPr>
        <p:spPr>
          <a:xfrm>
            <a:off x="1538640" y="2241720"/>
            <a:ext cx="1069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IB: synuclein-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(BD Transduction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テキスト ボックス 160"/>
          <p:cNvSpPr/>
          <p:nvPr/>
        </p:nvSpPr>
        <p:spPr>
          <a:xfrm>
            <a:off x="1538640" y="2557440"/>
            <a:ext cx="1069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IB: </a:t>
            </a:r>
            <a:r>
              <a:rPr b="1" lang="el-GR" sz="8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-synuclein 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(BD Transduction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テキスト ボックス 161"/>
          <p:cNvSpPr/>
          <p:nvPr/>
        </p:nvSpPr>
        <p:spPr>
          <a:xfrm>
            <a:off x="1546200" y="2873520"/>
            <a:ext cx="906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IB: </a:t>
            </a:r>
            <a:r>
              <a:rPr b="1" lang="el-GR" sz="800" spc="-1" strike="noStrike">
                <a:solidFill>
                  <a:srgbClr val="000000"/>
                </a:solidFill>
                <a:latin typeface="Arial"/>
                <a:ea typeface="Arial"/>
              </a:rPr>
              <a:t>γ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-synuclei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(GeneTex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テキスト ボックス 162"/>
          <p:cNvSpPr/>
          <p:nvPr/>
        </p:nvSpPr>
        <p:spPr>
          <a:xfrm>
            <a:off x="1538640" y="1925640"/>
            <a:ext cx="543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IB: Myc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(9E10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Text Box 95"/>
          <p:cNvSpPr/>
          <p:nvPr/>
        </p:nvSpPr>
        <p:spPr>
          <a:xfrm>
            <a:off x="530280" y="207972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17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Line 103"/>
          <p:cNvSpPr/>
          <p:nvPr/>
        </p:nvSpPr>
        <p:spPr>
          <a:xfrm flipH="1">
            <a:off x="730080" y="2179800"/>
            <a:ext cx="46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Text Box 95"/>
          <p:cNvSpPr/>
          <p:nvPr/>
        </p:nvSpPr>
        <p:spPr>
          <a:xfrm>
            <a:off x="530280" y="240516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17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Line 103"/>
          <p:cNvSpPr/>
          <p:nvPr/>
        </p:nvSpPr>
        <p:spPr>
          <a:xfrm flipH="1">
            <a:off x="730080" y="2505240"/>
            <a:ext cx="46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Text Box 95"/>
          <p:cNvSpPr/>
          <p:nvPr/>
        </p:nvSpPr>
        <p:spPr>
          <a:xfrm>
            <a:off x="530280" y="271152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17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Line 103"/>
          <p:cNvSpPr/>
          <p:nvPr/>
        </p:nvSpPr>
        <p:spPr>
          <a:xfrm flipH="1">
            <a:off x="730080" y="2811600"/>
            <a:ext cx="46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Text Box 95"/>
          <p:cNvSpPr/>
          <p:nvPr/>
        </p:nvSpPr>
        <p:spPr>
          <a:xfrm>
            <a:off x="530280" y="298440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17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Line 103"/>
          <p:cNvSpPr/>
          <p:nvPr/>
        </p:nvSpPr>
        <p:spPr>
          <a:xfrm flipH="1">
            <a:off x="730080" y="3084480"/>
            <a:ext cx="46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テキスト ボックス 171"/>
          <p:cNvSpPr/>
          <p:nvPr/>
        </p:nvSpPr>
        <p:spPr>
          <a:xfrm>
            <a:off x="537120" y="3095640"/>
            <a:ext cx="3164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kDa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テキスト ボックス 172"/>
          <p:cNvSpPr/>
          <p:nvPr/>
        </p:nvSpPr>
        <p:spPr>
          <a:xfrm rot="19185000">
            <a:off x="639720" y="1579680"/>
            <a:ext cx="746280" cy="29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Myc-</a:t>
            </a:r>
            <a:r>
              <a:rPr b="1" lang="el-GR" sz="900" spc="-1" strike="noStrike">
                <a:solidFill>
                  <a:srgbClr val="000000"/>
                </a:solidFill>
                <a:latin typeface="Arial"/>
                <a:ea typeface="Arial"/>
              </a:rPr>
              <a:t>α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SY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テキスト ボックス 173"/>
          <p:cNvSpPr/>
          <p:nvPr/>
        </p:nvSpPr>
        <p:spPr>
          <a:xfrm rot="19283400">
            <a:off x="900720" y="1578600"/>
            <a:ext cx="746280" cy="29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Myc-</a:t>
            </a:r>
            <a:r>
              <a:rPr b="1" lang="el-GR" sz="9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SY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6-08T09:41:40Z</dcterms:created>
  <dc:creator>Hasegawa Takafumi</dc:creator>
  <dc:description/>
  <dc:language>en-US</dc:language>
  <cp:lastModifiedBy>Hasegawa Takafumi</cp:lastModifiedBy>
  <dcterms:modified xsi:type="dcterms:W3CDTF">2012-06-08T23:39:33Z</dcterms:modified>
  <cp:revision>3</cp:revision>
  <dc:subject/>
  <dc:title>PowerPoint プレゼンテーション</dc:title>
</cp:coreProperties>
</file>